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wmf" ContentType="image/x-w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wmf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2274" y="-7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05121BE-2F1B-47FA-BC06-2B090CE1C554}" type="datetimeFigureOut">
              <a:rPr lang="en-US"/>
              <a:pPr>
                <a:defRPr/>
              </a:pPr>
              <a:t>12/3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E8110D2-71D3-4BA8-9DE9-3A5B140D7A0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C7A9E07-3639-49D0-88DE-EE5826EC5B2B}" type="datetimeFigureOut">
              <a:rPr lang="en-US"/>
              <a:pPr>
                <a:defRPr/>
              </a:pPr>
              <a:t>12/3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2B3451E-6D30-40BF-A3D2-FA66C5DB7E0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8A36885-5581-4232-9F6B-17EA0E20A754}" type="datetimeFigureOut">
              <a:rPr lang="en-US"/>
              <a:pPr>
                <a:defRPr/>
              </a:pPr>
              <a:t>12/3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3B04078-731C-4BFB-8F9D-64D504E74EE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418C7A-CBE6-4DBE-A27D-FBD2EC7AE647}" type="datetimeFigureOut">
              <a:rPr lang="en-US"/>
              <a:pPr>
                <a:defRPr/>
              </a:pPr>
              <a:t>12/3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FD40F1-2584-41BB-A95B-CF4BE329627E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63DAFFE-3201-4869-8ECF-51A6E8118918}" type="datetimeFigureOut">
              <a:rPr lang="en-US"/>
              <a:pPr>
                <a:defRPr/>
              </a:pPr>
              <a:t>12/3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4A38E5B-20EF-4BD2-A1A6-A361ADE1D4F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D0D3D6B-68F9-46F4-AAF8-2AA51779EF90}" type="datetimeFigureOut">
              <a:rPr lang="en-US"/>
              <a:pPr>
                <a:defRPr/>
              </a:pPr>
              <a:t>12/3/201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ABA4FE8-1C6D-4709-B186-8A9EFA6841FD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7025B2B-B10A-4A5C-B715-51C03D95899E}" type="datetimeFigureOut">
              <a:rPr lang="en-US"/>
              <a:pPr>
                <a:defRPr/>
              </a:pPr>
              <a:t>12/3/2012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9881A69-78B6-4DD3-B484-BC60E2C0370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7ADF1EA-CB43-41A2-8E91-01D9FDF807DC}" type="datetimeFigureOut">
              <a:rPr lang="en-US"/>
              <a:pPr>
                <a:defRPr/>
              </a:pPr>
              <a:t>12/3/2012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E06E19D-612B-4B1F-9FB9-5CEBF5D2411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871A0EF-F7D6-4681-BAED-FDDC41787F7B}" type="datetimeFigureOut">
              <a:rPr lang="en-US"/>
              <a:pPr>
                <a:defRPr/>
              </a:pPr>
              <a:t>12/3/2012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355851-4082-4AA2-B495-0B903117CC1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CB42EDA-53B1-4192-8199-18D5E5ECF200}" type="datetimeFigureOut">
              <a:rPr lang="en-US"/>
              <a:pPr>
                <a:defRPr/>
              </a:pPr>
              <a:t>12/3/201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847A85B-FCAF-49DA-99AC-B90158BB98E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CE44465-5760-47FC-A585-05389FA37BCF}" type="datetimeFigureOut">
              <a:rPr lang="en-US"/>
              <a:pPr>
                <a:defRPr/>
              </a:pPr>
              <a:t>12/3/201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3A169EE-E023-4F7D-95DB-885DC520677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itle style</a:t>
            </a:r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663"/>
            <a:ext cx="16002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89B3A240-A014-4B6D-9AC9-3F11E2A3D838}" type="datetimeFigureOut">
              <a:rPr lang="en-US"/>
              <a:pPr>
                <a:defRPr/>
              </a:pPr>
              <a:t>12/3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663"/>
            <a:ext cx="21717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663"/>
            <a:ext cx="16002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5481A07B-AE75-46FF-9EC2-48A732AF70D3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9" r:id="rId1"/>
    <p:sldLayoutId id="2147483658" r:id="rId2"/>
    <p:sldLayoutId id="2147483657" r:id="rId3"/>
    <p:sldLayoutId id="2147483656" r:id="rId4"/>
    <p:sldLayoutId id="2147483655" r:id="rId5"/>
    <p:sldLayoutId id="2147483654" r:id="rId6"/>
    <p:sldLayoutId id="2147483653" r:id="rId7"/>
    <p:sldLayoutId id="2147483652" r:id="rId8"/>
    <p:sldLayoutId id="2147483651" r:id="rId9"/>
    <p:sldLayoutId id="2147483650" r:id="rId10"/>
    <p:sldLayoutId id="2147483649" r:id="rId11"/>
  </p:sldLayoutIdLst>
  <p:txStyles>
    <p:titleStyle>
      <a:lvl1pPr algn="ctr" rtl="0" fontAlgn="base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fontAlgn="base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fontAlgn="base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fontAlgn="base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fontAlgn="base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fontAlgn="base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313" name="Rectangle 6"/>
          <p:cNvSpPr>
            <a:spLocks noChangeArrowheads="1"/>
          </p:cNvSpPr>
          <p:nvPr/>
        </p:nvSpPr>
        <p:spPr bwMode="auto">
          <a:xfrm>
            <a:off x="268288" y="6781800"/>
            <a:ext cx="6248400" cy="11699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sz="1000" b="1">
                <a:latin typeface="Times New Roman" pitchFamily="18" charset="0"/>
                <a:cs typeface="Times New Roman" pitchFamily="18" charset="0"/>
              </a:rPr>
              <a:t>Figure S3. Association between DNA copy number-associated differentially expressed genes and survival in the validation dataset excluding HPV+ oropharyngeal carcinomas. </a:t>
            </a:r>
            <a:r>
              <a:rPr lang="en-US" sz="1000">
                <a:latin typeface="Times New Roman" pitchFamily="18" charset="0"/>
                <a:cs typeface="Times New Roman" pitchFamily="18" charset="0"/>
              </a:rPr>
              <a:t>A) Hierarchical clustering of the 133-patient dataset excluding the HPV+ oropharyngeal carcinomas using the 95 CNA-associated differentially-expressed gene signature. Expression variances of the genes were summarized by principal components analysis. A hierarchical clustering analysis was performed using the first three principal component (PC) scores; B) Overall survival of the two patient clusters stratified by the 95-CNA-associated differentially expressed signature; C) Cumulative incidence of OSCC-specific death for the two patient clusters. </a:t>
            </a:r>
          </a:p>
        </p:txBody>
      </p:sp>
      <p:pic>
        <p:nvPicPr>
          <p:cNvPr id="13316" name="Picture 4" descr="S3-cx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981200" y="533400"/>
            <a:ext cx="2605088" cy="6197600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14</TotalTime>
  <Words>90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Design Templat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Calibri</vt:lpstr>
      <vt:lpstr>Arial</vt:lpstr>
      <vt:lpstr>Times New Roman</vt:lpstr>
      <vt:lpstr>Office Theme</vt:lpstr>
      <vt:lpstr>Slide 1</vt:lpstr>
    </vt:vector>
  </TitlesOfParts>
  <Company>Fred Hutchinson Cancer Research Center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Xu, Chang</dc:creator>
  <cp:lastModifiedBy>cxu</cp:lastModifiedBy>
  <cp:revision>46</cp:revision>
  <dcterms:created xsi:type="dcterms:W3CDTF">2011-06-08T23:30:32Z</dcterms:created>
  <dcterms:modified xsi:type="dcterms:W3CDTF">2012-12-03T18:34:29Z</dcterms:modified>
</cp:coreProperties>
</file>